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8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9D32CF-31C9-4B4A-837C-76844392BA67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FFD8A-2C7F-468D-BD45-2641EC6CCE5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05552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1731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2739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9859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482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4165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8300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43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1551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8557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5081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7537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A7894-053C-4F87-B67F-B3878E5F0AF6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F57EC-BD74-4D1E-AB51-6CC917BC33C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6738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D2BDD5B4-17E3-F185-207F-397DCB67C5F5}"/>
              </a:ext>
            </a:extLst>
          </p:cNvPr>
          <p:cNvGrpSpPr/>
          <p:nvPr/>
        </p:nvGrpSpPr>
        <p:grpSpPr>
          <a:xfrm>
            <a:off x="2165615" y="1106213"/>
            <a:ext cx="3328770" cy="1669435"/>
            <a:chOff x="2100530" y="2798062"/>
            <a:chExt cx="4165287" cy="1773938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2A7426EF-AF29-E6FA-671A-293BC9E142B0}"/>
                </a:ext>
              </a:extLst>
            </p:cNvPr>
            <p:cNvGrpSpPr/>
            <p:nvPr/>
          </p:nvGrpSpPr>
          <p:grpSpPr>
            <a:xfrm>
              <a:off x="2100530" y="2798062"/>
              <a:ext cx="1975081" cy="1773938"/>
              <a:chOff x="1198245" y="2775123"/>
              <a:chExt cx="3723136" cy="2594521"/>
            </a:xfrm>
          </p:grpSpPr>
          <p:sp>
            <p:nvSpPr>
              <p:cNvPr id="9" name="Forma libre: forma 8">
                <a:extLst>
                  <a:ext uri="{FF2B5EF4-FFF2-40B4-BE49-F238E27FC236}">
                    <a16:creationId xmlns:a16="http://schemas.microsoft.com/office/drawing/2014/main" id="{0D168146-53BB-60E1-36E3-36B44CB2500A}"/>
                  </a:ext>
                </a:extLst>
              </p:cNvPr>
              <p:cNvSpPr/>
              <p:nvPr/>
            </p:nvSpPr>
            <p:spPr>
              <a:xfrm>
                <a:off x="1198245" y="2775123"/>
                <a:ext cx="3723136" cy="1037808"/>
              </a:xfrm>
              <a:custGeom>
                <a:avLst/>
                <a:gdLst>
                  <a:gd name="connsiteX0" fmla="*/ 0 w 3723136"/>
                  <a:gd name="connsiteY0" fmla="*/ 103781 h 1037808"/>
                  <a:gd name="connsiteX1" fmla="*/ 103781 w 3723136"/>
                  <a:gd name="connsiteY1" fmla="*/ 0 h 1037808"/>
                  <a:gd name="connsiteX2" fmla="*/ 3619355 w 3723136"/>
                  <a:gd name="connsiteY2" fmla="*/ 0 h 1037808"/>
                  <a:gd name="connsiteX3" fmla="*/ 3723136 w 3723136"/>
                  <a:gd name="connsiteY3" fmla="*/ 103781 h 1037808"/>
                  <a:gd name="connsiteX4" fmla="*/ 3723136 w 3723136"/>
                  <a:gd name="connsiteY4" fmla="*/ 934027 h 1037808"/>
                  <a:gd name="connsiteX5" fmla="*/ 3619355 w 3723136"/>
                  <a:gd name="connsiteY5" fmla="*/ 1037808 h 1037808"/>
                  <a:gd name="connsiteX6" fmla="*/ 103781 w 3723136"/>
                  <a:gd name="connsiteY6" fmla="*/ 1037808 h 1037808"/>
                  <a:gd name="connsiteX7" fmla="*/ 0 w 3723136"/>
                  <a:gd name="connsiteY7" fmla="*/ 934027 h 1037808"/>
                  <a:gd name="connsiteX8" fmla="*/ 0 w 3723136"/>
                  <a:gd name="connsiteY8" fmla="*/ 103781 h 10378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3723136" h="1037808">
                    <a:moveTo>
                      <a:pt x="0" y="103781"/>
                    </a:moveTo>
                    <a:cubicBezTo>
                      <a:pt x="0" y="46464"/>
                      <a:pt x="46464" y="0"/>
                      <a:pt x="103781" y="0"/>
                    </a:cubicBezTo>
                    <a:lnTo>
                      <a:pt x="3619355" y="0"/>
                    </a:lnTo>
                    <a:cubicBezTo>
                      <a:pt x="3676672" y="0"/>
                      <a:pt x="3723136" y="46464"/>
                      <a:pt x="3723136" y="103781"/>
                    </a:cubicBezTo>
                    <a:lnTo>
                      <a:pt x="3723136" y="934027"/>
                    </a:lnTo>
                    <a:cubicBezTo>
                      <a:pt x="3723136" y="991344"/>
                      <a:pt x="3676672" y="1037808"/>
                      <a:pt x="3619355" y="1037808"/>
                    </a:cubicBezTo>
                    <a:lnTo>
                      <a:pt x="103781" y="1037808"/>
                    </a:lnTo>
                    <a:cubicBezTo>
                      <a:pt x="46464" y="1037808"/>
                      <a:pt x="0" y="991344"/>
                      <a:pt x="0" y="934027"/>
                    </a:cubicBezTo>
                    <a:lnTo>
                      <a:pt x="0" y="103781"/>
                    </a:lnTo>
                    <a:close/>
                  </a:path>
                </a:pathLst>
              </a:custGeom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l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98976" tIns="98976" rIns="98976" bIns="98976" numCol="1" spcCol="1270" anchor="ctr" anchorCtr="0">
                <a:noAutofit/>
              </a:bodyPr>
              <a:lstStyle/>
              <a:p>
                <a:pPr marL="0" lvl="0" indent="0" algn="ctr" defTabSz="8001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dividuals</a:t>
                </a: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gistered</a:t>
                </a: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in </a:t>
                </a: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e</a:t>
                </a: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tabase</a:t>
                </a:r>
                <a:endParaRPr lang="es-ES" sz="1050" b="0" kern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marL="0" lvl="0" indent="0" algn="ctr" defTabSz="8001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n=)</a:t>
                </a:r>
              </a:p>
            </p:txBody>
          </p:sp>
          <p:sp>
            <p:nvSpPr>
              <p:cNvPr id="10" name="Forma libre: forma 9">
                <a:extLst>
                  <a:ext uri="{FF2B5EF4-FFF2-40B4-BE49-F238E27FC236}">
                    <a16:creationId xmlns:a16="http://schemas.microsoft.com/office/drawing/2014/main" id="{925FA4C8-99DE-4247-0985-276CE9A70A07}"/>
                  </a:ext>
                </a:extLst>
              </p:cNvPr>
              <p:cNvSpPr/>
              <p:nvPr/>
            </p:nvSpPr>
            <p:spPr>
              <a:xfrm>
                <a:off x="1198245" y="4331836"/>
                <a:ext cx="3723136" cy="1037808"/>
              </a:xfrm>
              <a:custGeom>
                <a:avLst/>
                <a:gdLst>
                  <a:gd name="connsiteX0" fmla="*/ 0 w 3723136"/>
                  <a:gd name="connsiteY0" fmla="*/ 103781 h 1037808"/>
                  <a:gd name="connsiteX1" fmla="*/ 103781 w 3723136"/>
                  <a:gd name="connsiteY1" fmla="*/ 0 h 1037808"/>
                  <a:gd name="connsiteX2" fmla="*/ 3619355 w 3723136"/>
                  <a:gd name="connsiteY2" fmla="*/ 0 h 1037808"/>
                  <a:gd name="connsiteX3" fmla="*/ 3723136 w 3723136"/>
                  <a:gd name="connsiteY3" fmla="*/ 103781 h 1037808"/>
                  <a:gd name="connsiteX4" fmla="*/ 3723136 w 3723136"/>
                  <a:gd name="connsiteY4" fmla="*/ 934027 h 1037808"/>
                  <a:gd name="connsiteX5" fmla="*/ 3619355 w 3723136"/>
                  <a:gd name="connsiteY5" fmla="*/ 1037808 h 1037808"/>
                  <a:gd name="connsiteX6" fmla="*/ 103781 w 3723136"/>
                  <a:gd name="connsiteY6" fmla="*/ 1037808 h 1037808"/>
                  <a:gd name="connsiteX7" fmla="*/ 0 w 3723136"/>
                  <a:gd name="connsiteY7" fmla="*/ 934027 h 1037808"/>
                  <a:gd name="connsiteX8" fmla="*/ 0 w 3723136"/>
                  <a:gd name="connsiteY8" fmla="*/ 103781 h 10378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3723136" h="1037808">
                    <a:moveTo>
                      <a:pt x="0" y="103781"/>
                    </a:moveTo>
                    <a:cubicBezTo>
                      <a:pt x="0" y="46464"/>
                      <a:pt x="46464" y="0"/>
                      <a:pt x="103781" y="0"/>
                    </a:cubicBezTo>
                    <a:lnTo>
                      <a:pt x="3619355" y="0"/>
                    </a:lnTo>
                    <a:cubicBezTo>
                      <a:pt x="3676672" y="0"/>
                      <a:pt x="3723136" y="46464"/>
                      <a:pt x="3723136" y="103781"/>
                    </a:cubicBezTo>
                    <a:lnTo>
                      <a:pt x="3723136" y="934027"/>
                    </a:lnTo>
                    <a:cubicBezTo>
                      <a:pt x="3723136" y="991344"/>
                      <a:pt x="3676672" y="1037808"/>
                      <a:pt x="3619355" y="1037808"/>
                    </a:cubicBezTo>
                    <a:lnTo>
                      <a:pt x="103781" y="1037808"/>
                    </a:lnTo>
                    <a:cubicBezTo>
                      <a:pt x="46464" y="1037808"/>
                      <a:pt x="0" y="991344"/>
                      <a:pt x="0" y="934027"/>
                    </a:cubicBezTo>
                    <a:lnTo>
                      <a:pt x="0" y="103781"/>
                    </a:lnTo>
                    <a:close/>
                  </a:path>
                </a:pathLst>
              </a:custGeom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l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98976" tIns="98976" rIns="98976" bIns="98976" numCol="1" spcCol="1270" anchor="ctr" anchorCtr="0">
                <a:noAutofit/>
              </a:bodyPr>
              <a:lstStyle/>
              <a:p>
                <a:pPr marL="0" lvl="0" indent="0" algn="ctr" defTabSz="8001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dividuals</a:t>
                </a: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cluded</a:t>
                </a: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in </a:t>
                </a: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e</a:t>
                </a: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1050" b="0" kern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alysis</a:t>
                </a:r>
                <a:endParaRPr lang="es-ES" sz="1050" b="0" kern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marL="0" lvl="0" indent="0" algn="ctr" defTabSz="8001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s-ES" sz="1050" b="0" kern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n=21,495)</a:t>
                </a:r>
              </a:p>
            </p:txBody>
          </p:sp>
        </p:grpSp>
        <p:sp>
          <p:nvSpPr>
            <p:cNvPr id="6" name="Forma libre: forma 5">
              <a:extLst>
                <a:ext uri="{FF2B5EF4-FFF2-40B4-BE49-F238E27FC236}">
                  <a16:creationId xmlns:a16="http://schemas.microsoft.com/office/drawing/2014/main" id="{5328F1C3-7220-39B9-A063-6B323409B471}"/>
                </a:ext>
              </a:extLst>
            </p:cNvPr>
            <p:cNvSpPr/>
            <p:nvPr/>
          </p:nvSpPr>
          <p:spPr>
            <a:xfrm>
              <a:off x="4290736" y="3305250"/>
              <a:ext cx="1975081" cy="709575"/>
            </a:xfrm>
            <a:custGeom>
              <a:avLst/>
              <a:gdLst>
                <a:gd name="connsiteX0" fmla="*/ 0 w 3723136"/>
                <a:gd name="connsiteY0" fmla="*/ 103781 h 1037808"/>
                <a:gd name="connsiteX1" fmla="*/ 103781 w 3723136"/>
                <a:gd name="connsiteY1" fmla="*/ 0 h 1037808"/>
                <a:gd name="connsiteX2" fmla="*/ 3619355 w 3723136"/>
                <a:gd name="connsiteY2" fmla="*/ 0 h 1037808"/>
                <a:gd name="connsiteX3" fmla="*/ 3723136 w 3723136"/>
                <a:gd name="connsiteY3" fmla="*/ 103781 h 1037808"/>
                <a:gd name="connsiteX4" fmla="*/ 3723136 w 3723136"/>
                <a:gd name="connsiteY4" fmla="*/ 934027 h 1037808"/>
                <a:gd name="connsiteX5" fmla="*/ 3619355 w 3723136"/>
                <a:gd name="connsiteY5" fmla="*/ 1037808 h 1037808"/>
                <a:gd name="connsiteX6" fmla="*/ 103781 w 3723136"/>
                <a:gd name="connsiteY6" fmla="*/ 1037808 h 1037808"/>
                <a:gd name="connsiteX7" fmla="*/ 0 w 3723136"/>
                <a:gd name="connsiteY7" fmla="*/ 934027 h 1037808"/>
                <a:gd name="connsiteX8" fmla="*/ 0 w 3723136"/>
                <a:gd name="connsiteY8" fmla="*/ 103781 h 10378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723136" h="1037808">
                  <a:moveTo>
                    <a:pt x="0" y="103781"/>
                  </a:moveTo>
                  <a:cubicBezTo>
                    <a:pt x="0" y="46464"/>
                    <a:pt x="46464" y="0"/>
                    <a:pt x="103781" y="0"/>
                  </a:cubicBezTo>
                  <a:lnTo>
                    <a:pt x="3619355" y="0"/>
                  </a:lnTo>
                  <a:cubicBezTo>
                    <a:pt x="3676672" y="0"/>
                    <a:pt x="3723136" y="46464"/>
                    <a:pt x="3723136" y="103781"/>
                  </a:cubicBezTo>
                  <a:lnTo>
                    <a:pt x="3723136" y="934027"/>
                  </a:lnTo>
                  <a:cubicBezTo>
                    <a:pt x="3723136" y="991344"/>
                    <a:pt x="3676672" y="1037808"/>
                    <a:pt x="3619355" y="1037808"/>
                  </a:cubicBezTo>
                  <a:lnTo>
                    <a:pt x="103781" y="1037808"/>
                  </a:lnTo>
                  <a:cubicBezTo>
                    <a:pt x="46464" y="1037808"/>
                    <a:pt x="0" y="991344"/>
                    <a:pt x="0" y="934027"/>
                  </a:cubicBezTo>
                  <a:lnTo>
                    <a:pt x="0" y="103781"/>
                  </a:lnTo>
                  <a:close/>
                </a:path>
              </a:pathLst>
            </a:custGeom>
            <a:ln>
              <a:prstDash val="sysDash"/>
            </a:ln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98976" tIns="98976" rIns="98976" bIns="98976" numCol="1" spcCol="1270" anchor="ctr" anchorCtr="0">
              <a:noAutofit/>
            </a:bodyPr>
            <a:lstStyle/>
            <a:p>
              <a:pPr marL="0" lvl="0" indent="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s-ES" sz="1050" b="0" kern="1200" dirty="0">
                  <a:latin typeface="Arial" panose="020B0604020202020204" pitchFamily="34" charset="0"/>
                  <a:cs typeface="Arial" panose="020B0604020202020204" pitchFamily="34" charset="0"/>
                </a:rPr>
                <a:t>Poor </a:t>
              </a:r>
              <a:r>
                <a:rPr lang="es-ES" sz="1050" b="0" kern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quality</a:t>
              </a:r>
              <a:r>
                <a:rPr lang="es-ES" sz="1050" b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5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or</a:t>
              </a:r>
              <a:r>
                <a:rPr lang="es-ES" sz="1050" b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50" b="0" dirty="0" err="1">
                  <a:latin typeface="Arial" panose="020B0604020202020204" pitchFamily="34" charset="0"/>
                  <a:cs typeface="Arial" panose="020B0604020202020204" pitchFamily="34" charset="0"/>
                </a:rPr>
                <a:t>missing</a:t>
              </a:r>
              <a:r>
                <a:rPr lang="es-ES" sz="1050" b="0" dirty="0">
                  <a:latin typeface="Arial" panose="020B0604020202020204" pitchFamily="34" charset="0"/>
                  <a:cs typeface="Arial" panose="020B0604020202020204" pitchFamily="34" charset="0"/>
                </a:rPr>
                <a:t> data</a:t>
              </a:r>
              <a:endParaRPr lang="es-ES" sz="1050" b="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lvl="0" indent="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s-ES" sz="1050" b="0" kern="1200" dirty="0">
                  <a:latin typeface="Arial" panose="020B0604020202020204" pitchFamily="34" charset="0"/>
                  <a:cs typeface="Arial" panose="020B0604020202020204" pitchFamily="34" charset="0"/>
                </a:rPr>
                <a:t>(n=)</a:t>
              </a:r>
            </a:p>
          </p:txBody>
        </p:sp>
        <p:cxnSp>
          <p:nvCxnSpPr>
            <p:cNvPr id="7" name="Conector recto de flecha 6">
              <a:extLst>
                <a:ext uri="{FF2B5EF4-FFF2-40B4-BE49-F238E27FC236}">
                  <a16:creationId xmlns:a16="http://schemas.microsoft.com/office/drawing/2014/main" id="{CD742F27-9ABD-328B-3BE9-28BDB1CE60DE}"/>
                </a:ext>
              </a:extLst>
            </p:cNvPr>
            <p:cNvCxnSpPr/>
            <p:nvPr/>
          </p:nvCxnSpPr>
          <p:spPr>
            <a:xfrm>
              <a:off x="3088070" y="3507637"/>
              <a:ext cx="0" cy="35478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ctor recto de flecha 7">
              <a:extLst>
                <a:ext uri="{FF2B5EF4-FFF2-40B4-BE49-F238E27FC236}">
                  <a16:creationId xmlns:a16="http://schemas.microsoft.com/office/drawing/2014/main" id="{1C0401C9-F2A4-308B-46B0-3F7181279A39}"/>
                </a:ext>
              </a:extLst>
            </p:cNvPr>
            <p:cNvCxnSpPr>
              <a:cxnSpLocks/>
            </p:cNvCxnSpPr>
            <p:nvPr/>
          </p:nvCxnSpPr>
          <p:spPr>
            <a:xfrm>
              <a:off x="3088070" y="3660037"/>
              <a:ext cx="120266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8" name="Imagen 17">
            <a:extLst>
              <a:ext uri="{FF2B5EF4-FFF2-40B4-BE49-F238E27FC236}">
                <a16:creationId xmlns:a16="http://schemas.microsoft.com/office/drawing/2014/main" id="{96D8E3FC-05A7-1FDD-A472-2CBA63B6BA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6061" y="4742261"/>
            <a:ext cx="4318666" cy="3246330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378CC422-A713-4741-D315-9E556D7ED8A6}"/>
              </a:ext>
            </a:extLst>
          </p:cNvPr>
          <p:cNvSpPr txBox="1"/>
          <p:nvPr/>
        </p:nvSpPr>
        <p:spPr>
          <a:xfrm>
            <a:off x="328327" y="452263"/>
            <a:ext cx="592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0968CF9A-D09A-8561-016E-6AA5756CAF3C}"/>
              </a:ext>
            </a:extLst>
          </p:cNvPr>
          <p:cNvSpPr txBox="1"/>
          <p:nvPr/>
        </p:nvSpPr>
        <p:spPr>
          <a:xfrm>
            <a:off x="329034" y="4419146"/>
            <a:ext cx="592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70887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>
            <a:extLst>
              <a:ext uri="{FF2B5EF4-FFF2-40B4-BE49-F238E27FC236}">
                <a16:creationId xmlns:a16="http://schemas.microsoft.com/office/drawing/2014/main" id="{F49F6904-C983-52D8-2EA4-49AE3FD7D1B9}"/>
              </a:ext>
            </a:extLst>
          </p:cNvPr>
          <p:cNvGrpSpPr/>
          <p:nvPr/>
        </p:nvGrpSpPr>
        <p:grpSpPr>
          <a:xfrm>
            <a:off x="328327" y="452263"/>
            <a:ext cx="6170274" cy="9135495"/>
            <a:chOff x="328327" y="452263"/>
            <a:chExt cx="6170274" cy="9135495"/>
          </a:xfrm>
        </p:grpSpPr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B50202FE-15A8-BFA5-512B-66C8079B15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4697" y="4721680"/>
              <a:ext cx="2835908" cy="2399897"/>
            </a:xfrm>
            <a:prstGeom prst="rect">
              <a:avLst/>
            </a:prstGeom>
          </p:spPr>
        </p:pic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36C1374E-89ED-6F95-1781-BE8711C27F2F}"/>
                </a:ext>
              </a:extLst>
            </p:cNvPr>
            <p:cNvSpPr txBox="1"/>
            <p:nvPr/>
          </p:nvSpPr>
          <p:spPr>
            <a:xfrm>
              <a:off x="329034" y="4419146"/>
              <a:ext cx="5921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EA66FC56-C1A7-CE9D-A9BF-9D85F42F92F7}"/>
                </a:ext>
              </a:extLst>
            </p:cNvPr>
            <p:cNvSpPr txBox="1"/>
            <p:nvPr/>
          </p:nvSpPr>
          <p:spPr>
            <a:xfrm>
              <a:off x="3576967" y="4413968"/>
              <a:ext cx="5921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F0258A2D-95EB-D07D-64A3-BB55F62E785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62695" y="4721679"/>
              <a:ext cx="2835906" cy="2399897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0B2CB283-7DFB-997E-07FB-161658776E44}"/>
                </a:ext>
              </a:extLst>
            </p:cNvPr>
            <p:cNvSpPr txBox="1"/>
            <p:nvPr/>
          </p:nvSpPr>
          <p:spPr>
            <a:xfrm>
              <a:off x="4941263" y="9341537"/>
              <a:ext cx="1557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</a:t>
              </a:r>
              <a:r>
                <a:rPr lang="es-E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1</a:t>
              </a:r>
              <a:endParaRPr lang="es-E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340D74FD-16AD-4E81-09A7-3DA109308DB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4697" y="821595"/>
              <a:ext cx="5678556" cy="3446284"/>
            </a:xfrm>
            <a:prstGeom prst="rect">
              <a:avLst/>
            </a:prstGeom>
          </p:spPr>
        </p:pic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1BFA8DEB-DDEF-4B9F-D4F3-8417F2CD1AB1}"/>
                </a:ext>
              </a:extLst>
            </p:cNvPr>
            <p:cNvSpPr txBox="1"/>
            <p:nvPr/>
          </p:nvSpPr>
          <p:spPr>
            <a:xfrm>
              <a:off x="328327" y="452263"/>
              <a:ext cx="5921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2238732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38</TotalTime>
  <Words>34</Words>
  <Application>Microsoft Office PowerPoint</Application>
  <PresentationFormat>A4 (210 x 297 mm)</PresentationFormat>
  <Paragraphs>12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iodonostia Onco Celular</dc:creator>
  <cp:lastModifiedBy>Sara Cruces Salguero</cp:lastModifiedBy>
  <cp:revision>42</cp:revision>
  <dcterms:created xsi:type="dcterms:W3CDTF">2023-07-06T14:22:37Z</dcterms:created>
  <dcterms:modified xsi:type="dcterms:W3CDTF">2024-10-29T14:31:35Z</dcterms:modified>
</cp:coreProperties>
</file>